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25" d="100"/>
          <a:sy n="125" d="100"/>
        </p:scale>
        <p:origin x="1614" y="7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shi, Aniket Sunil" userId="99c22df6-eccd-47fd-9b08-c584eb42b50d" providerId="ADAL" clId="{7E24928D-0DA9-4F6A-A7A9-B24B17E80209}"/>
    <pc:docChg chg="addSld modSld">
      <pc:chgData name="Joshi, Aniket Sunil" userId="99c22df6-eccd-47fd-9b08-c584eb42b50d" providerId="ADAL" clId="{7E24928D-0DA9-4F6A-A7A9-B24B17E80209}" dt="2025-08-23T16:59:45.511" v="22" actId="1035"/>
      <pc:docMkLst>
        <pc:docMk/>
      </pc:docMkLst>
      <pc:sldChg chg="addSp delSp modSp add">
        <pc:chgData name="Joshi, Aniket Sunil" userId="99c22df6-eccd-47fd-9b08-c584eb42b50d" providerId="ADAL" clId="{7E24928D-0DA9-4F6A-A7A9-B24B17E80209}" dt="2025-08-23T16:59:45.511" v="22" actId="1035"/>
        <pc:sldMkLst>
          <pc:docMk/>
          <pc:sldMk cId="1484563804" sldId="256"/>
        </pc:sldMkLst>
        <pc:spChg chg="del">
          <ac:chgData name="Joshi, Aniket Sunil" userId="99c22df6-eccd-47fd-9b08-c584eb42b50d" providerId="ADAL" clId="{7E24928D-0DA9-4F6A-A7A9-B24B17E80209}" dt="2025-08-22T22:57:49.297" v="1"/>
          <ac:spMkLst>
            <pc:docMk/>
            <pc:sldMk cId="1484563804" sldId="256"/>
            <ac:spMk id="2" creationId="{59D29C8A-223E-4E1B-BD55-48E2BD70D8B9}"/>
          </ac:spMkLst>
        </pc:spChg>
        <pc:spChg chg="del">
          <ac:chgData name="Joshi, Aniket Sunil" userId="99c22df6-eccd-47fd-9b08-c584eb42b50d" providerId="ADAL" clId="{7E24928D-0DA9-4F6A-A7A9-B24B17E80209}" dt="2025-08-22T22:57:49.297" v="1"/>
          <ac:spMkLst>
            <pc:docMk/>
            <pc:sldMk cId="1484563804" sldId="256"/>
            <ac:spMk id="3" creationId="{FE26B7FB-46B5-4C12-A1F7-2FDFB9C33A8E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4" creationId="{DDED6EB2-4FE7-4241-895C-7193506CCC1E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5" creationId="{A629D2CC-6A17-478F-9075-6DB9BBC3251D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6" creationId="{98D5F5F9-ED3F-45A8-830A-B7995E450D80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7" creationId="{2B902153-BC1C-481D-8C89-C166AA78B674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10" creationId="{D51010E4-F6FA-4AA2-833B-25B2AA67144B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17" creationId="{26A3A7E8-0D20-4790-BDDA-1121691F0E70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18" creationId="{4F62A1EA-EEE3-4222-9DB7-F3539D66B5AD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19" creationId="{5797F082-C531-4F7E-AB70-111A80B07E96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20" creationId="{6C1E817D-3DB4-4AB9-9C3B-65C418A7E6A6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27" creationId="{6E866DCE-B217-484B-B21D-26CF5AA77183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28" creationId="{E6972856-DB0C-485D-8600-461ACF39A815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31" creationId="{46EE717D-9F4B-4D9A-9796-5F8AA64A4132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32" creationId="{37B88072-5863-41D3-855F-72B6CB7A665E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37" creationId="{B46C5BF2-4420-46B7-AF3A-E358C46E7A83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38" creationId="{B6132ACC-054C-493E-A9C8-E3C036E652D1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39" creationId="{81027C7E-EC5B-41DD-9B43-C08967F316CC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40" creationId="{84B1CEB5-C501-4BF6-B98B-4FBAB7A4DA7F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45" creationId="{F3EE5B06-791E-40B7-BB90-2AFB929EFF0C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47" creationId="{1A70EF27-47CE-4DA3-8919-37AD1C2CE086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48" creationId="{3614EA8C-3B83-4644-A1CF-66A118429C0F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49" creationId="{22EE764C-370A-4BED-80A0-2DE71C2CF1BD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52" creationId="{DC1DD82B-85D5-400C-A24F-BBC66218520C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53" creationId="{211F2621-A065-407F-8385-A51947F4D4DF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54" creationId="{8B9FEE9B-FCA3-423D-AD74-B2008405EA45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55" creationId="{C22FE1BC-A046-4220-BFFF-63B3642916D0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56" creationId="{D9F12BAB-450F-4D74-84E1-44E1ED5980DE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58" creationId="{FAB97107-4BE7-47EA-9326-77892F2E7AB9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60" creationId="{31BA3286-136E-4C2B-8E5E-EC2DB23786FA}"/>
          </ac:spMkLst>
        </pc:spChg>
        <pc:spChg chg="add mod">
          <ac:chgData name="Joshi, Aniket Sunil" userId="99c22df6-eccd-47fd-9b08-c584eb42b50d" providerId="ADAL" clId="{7E24928D-0DA9-4F6A-A7A9-B24B17E80209}" dt="2025-08-23T16:59:11.050" v="11" actId="1076"/>
          <ac:spMkLst>
            <pc:docMk/>
            <pc:sldMk cId="1484563804" sldId="256"/>
            <ac:spMk id="62" creationId="{B485F659-47A1-4AF5-BCD2-B088BAFA9AA6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63" creationId="{E9E26707-6F95-4921-B61B-FFC39488FCE4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64" creationId="{D0A29198-CCB2-4982-9837-A32C9380FEE1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65" creationId="{AD3FC1D6-72ED-49B5-B657-4CA89B7DB449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66" creationId="{086F8E4B-EF2D-423E-8B24-DA01510DBBDA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67" creationId="{773D4EC4-B2A3-405C-A039-1FF223F26203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69" creationId="{D46FD904-A4CD-4204-9466-1A4A68794CAC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71" creationId="{73E02869-B1BE-41D8-87C8-3CBB344DA147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74" creationId="{E8982295-E0CB-4581-BD5B-55FCA065915A}"/>
          </ac:spMkLst>
        </pc:spChg>
        <pc:spChg chg="add mod">
          <ac:chgData name="Joshi, Aniket Sunil" userId="99c22df6-eccd-47fd-9b08-c584eb42b50d" providerId="ADAL" clId="{7E24928D-0DA9-4F6A-A7A9-B24B17E80209}" dt="2025-08-22T22:58:08.027" v="5" actId="1076"/>
          <ac:spMkLst>
            <pc:docMk/>
            <pc:sldMk cId="1484563804" sldId="256"/>
            <ac:spMk id="76" creationId="{0EA1369D-7FF4-4EC5-BFCB-11A8AD17A6AF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77" creationId="{B36E0F33-9408-41F8-9E89-DF185D93C20B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78" creationId="{8F709D37-FB48-47BB-935E-B07EEA2A5F3D}"/>
          </ac:spMkLst>
        </pc:spChg>
        <pc:spChg chg="add mod">
          <ac:chgData name="Joshi, Aniket Sunil" userId="99c22df6-eccd-47fd-9b08-c584eb42b50d" providerId="ADAL" clId="{7E24928D-0DA9-4F6A-A7A9-B24B17E80209}" dt="2025-08-22T22:58:16.481" v="7" actId="1076"/>
          <ac:spMkLst>
            <pc:docMk/>
            <pc:sldMk cId="1484563804" sldId="256"/>
            <ac:spMk id="79" creationId="{AACA81AA-629F-4334-93E0-B02D4B87CF9B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80" creationId="{02CB74D0-EA9D-4C4F-8CAE-65584EDD5A1C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81" creationId="{C1BAA1B4-C1C1-4D8A-959E-2BA8B7FC006E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82" creationId="{08DC85A1-DB87-4BFC-993F-4E9F30B98AA4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84" creationId="{F9DFAE9C-3502-4876-9A13-FDB73AB60653}"/>
          </ac:spMkLst>
        </pc:spChg>
        <pc:spChg chg="add mod">
          <ac:chgData name="Joshi, Aniket Sunil" userId="99c22df6-eccd-47fd-9b08-c584eb42b50d" providerId="ADAL" clId="{7E24928D-0DA9-4F6A-A7A9-B24B17E80209}" dt="2025-08-23T16:59:06.524" v="10" actId="1076"/>
          <ac:spMkLst>
            <pc:docMk/>
            <pc:sldMk cId="1484563804" sldId="256"/>
            <ac:spMk id="87" creationId="{4BDB05D7-7360-4D34-AFD5-516123341F61}"/>
          </ac:spMkLst>
        </pc:spChg>
        <pc:picChg chg="add mod">
          <ac:chgData name="Joshi, Aniket Sunil" userId="99c22df6-eccd-47fd-9b08-c584eb42b50d" providerId="ADAL" clId="{7E24928D-0DA9-4F6A-A7A9-B24B17E80209}" dt="2025-08-22T22:58:16.481" v="7" actId="1076"/>
          <ac:picMkLst>
            <pc:docMk/>
            <pc:sldMk cId="1484563804" sldId="256"/>
            <ac:picMk id="8" creationId="{74C75CFF-70A3-48C2-ACAC-6B079A529397}"/>
          </ac:picMkLst>
        </pc:picChg>
        <pc:picChg chg="add mod">
          <ac:chgData name="Joshi, Aniket Sunil" userId="99c22df6-eccd-47fd-9b08-c584eb42b50d" providerId="ADAL" clId="{7E24928D-0DA9-4F6A-A7A9-B24B17E80209}" dt="2025-08-22T22:58:16.481" v="7" actId="1076"/>
          <ac:picMkLst>
            <pc:docMk/>
            <pc:sldMk cId="1484563804" sldId="256"/>
            <ac:picMk id="9" creationId="{CCB2479B-4B6A-4B67-AF20-3884C736C29B}"/>
          </ac:picMkLst>
        </pc:picChg>
        <pc:picChg chg="add mod">
          <ac:chgData name="Joshi, Aniket Sunil" userId="99c22df6-eccd-47fd-9b08-c584eb42b50d" providerId="ADAL" clId="{7E24928D-0DA9-4F6A-A7A9-B24B17E80209}" dt="2025-08-22T22:58:16.481" v="7" actId="1076"/>
          <ac:picMkLst>
            <pc:docMk/>
            <pc:sldMk cId="1484563804" sldId="256"/>
            <ac:picMk id="11" creationId="{3207B1D6-FA09-450D-A596-1BBA25C28600}"/>
          </ac:picMkLst>
        </pc:picChg>
        <pc:picChg chg="add mod">
          <ac:chgData name="Joshi, Aniket Sunil" userId="99c22df6-eccd-47fd-9b08-c584eb42b50d" providerId="ADAL" clId="{7E24928D-0DA9-4F6A-A7A9-B24B17E80209}" dt="2025-08-22T22:58:16.481" v="7" actId="1076"/>
          <ac:picMkLst>
            <pc:docMk/>
            <pc:sldMk cId="1484563804" sldId="256"/>
            <ac:picMk id="12" creationId="{894B1E65-C782-4907-89F0-B508DB4F68CE}"/>
          </ac:picMkLst>
        </pc:picChg>
        <pc:picChg chg="add mod">
          <ac:chgData name="Joshi, Aniket Sunil" userId="99c22df6-eccd-47fd-9b08-c584eb42b50d" providerId="ADAL" clId="{7E24928D-0DA9-4F6A-A7A9-B24B17E80209}" dt="2025-08-23T16:59:06.524" v="10" actId="1076"/>
          <ac:picMkLst>
            <pc:docMk/>
            <pc:sldMk cId="1484563804" sldId="256"/>
            <ac:picMk id="25" creationId="{97A1CAAD-E5B7-417A-BE39-47524B601CA6}"/>
          </ac:picMkLst>
        </pc:picChg>
        <pc:picChg chg="add mod">
          <ac:chgData name="Joshi, Aniket Sunil" userId="99c22df6-eccd-47fd-9b08-c584eb42b50d" providerId="ADAL" clId="{7E24928D-0DA9-4F6A-A7A9-B24B17E80209}" dt="2025-08-23T16:59:06.524" v="10" actId="1076"/>
          <ac:picMkLst>
            <pc:docMk/>
            <pc:sldMk cId="1484563804" sldId="256"/>
            <ac:picMk id="26" creationId="{980D749E-AB2B-4C67-96C2-74EB7FD659AE}"/>
          </ac:picMkLst>
        </pc:picChg>
        <pc:picChg chg="add mod">
          <ac:chgData name="Joshi, Aniket Sunil" userId="99c22df6-eccd-47fd-9b08-c584eb42b50d" providerId="ADAL" clId="{7E24928D-0DA9-4F6A-A7A9-B24B17E80209}" dt="2025-08-23T16:59:06.524" v="10" actId="1076"/>
          <ac:picMkLst>
            <pc:docMk/>
            <pc:sldMk cId="1484563804" sldId="256"/>
            <ac:picMk id="29" creationId="{04426669-5056-4AB6-8651-8837B9E38122}"/>
          </ac:picMkLst>
        </pc:picChg>
        <pc:picChg chg="add mod">
          <ac:chgData name="Joshi, Aniket Sunil" userId="99c22df6-eccd-47fd-9b08-c584eb42b50d" providerId="ADAL" clId="{7E24928D-0DA9-4F6A-A7A9-B24B17E80209}" dt="2025-08-23T16:59:06.524" v="10" actId="1076"/>
          <ac:picMkLst>
            <pc:docMk/>
            <pc:sldMk cId="1484563804" sldId="256"/>
            <ac:picMk id="30" creationId="{05A64AF2-2944-4B10-89C2-5B6CE0550E3D}"/>
          </ac:picMkLst>
        </pc:picChg>
        <pc:picChg chg="add mod">
          <ac:chgData name="Joshi, Aniket Sunil" userId="99c22df6-eccd-47fd-9b08-c584eb42b50d" providerId="ADAL" clId="{7E24928D-0DA9-4F6A-A7A9-B24B17E80209}" dt="2025-08-23T16:59:11.050" v="11" actId="1076"/>
          <ac:picMkLst>
            <pc:docMk/>
            <pc:sldMk cId="1484563804" sldId="256"/>
            <ac:picMk id="46" creationId="{ECD1D96B-DDEC-4DF1-977D-75A57A494CDE}"/>
          </ac:picMkLst>
        </pc:picChg>
        <pc:picChg chg="add mod">
          <ac:chgData name="Joshi, Aniket Sunil" userId="99c22df6-eccd-47fd-9b08-c584eb42b50d" providerId="ADAL" clId="{7E24928D-0DA9-4F6A-A7A9-B24B17E80209}" dt="2025-08-23T16:59:11.050" v="11" actId="1076"/>
          <ac:picMkLst>
            <pc:docMk/>
            <pc:sldMk cId="1484563804" sldId="256"/>
            <ac:picMk id="50" creationId="{ADBD84E0-F5E3-4FC0-9696-E34C88DB51C1}"/>
          </ac:picMkLst>
        </pc:picChg>
        <pc:picChg chg="add mod">
          <ac:chgData name="Joshi, Aniket Sunil" userId="99c22df6-eccd-47fd-9b08-c584eb42b50d" providerId="ADAL" clId="{7E24928D-0DA9-4F6A-A7A9-B24B17E80209}" dt="2025-08-23T16:59:11.050" v="11" actId="1076"/>
          <ac:picMkLst>
            <pc:docMk/>
            <pc:sldMk cId="1484563804" sldId="256"/>
            <ac:picMk id="51" creationId="{6338764D-0020-494B-A11C-999865E7F390}"/>
          </ac:picMkLst>
        </pc:picChg>
        <pc:picChg chg="add mod">
          <ac:chgData name="Joshi, Aniket Sunil" userId="99c22df6-eccd-47fd-9b08-c584eb42b50d" providerId="ADAL" clId="{7E24928D-0DA9-4F6A-A7A9-B24B17E80209}" dt="2025-08-22T22:58:08.027" v="5" actId="1076"/>
          <ac:picMkLst>
            <pc:docMk/>
            <pc:sldMk cId="1484563804" sldId="256"/>
            <ac:picMk id="68" creationId="{11B74018-7331-42D8-998A-318B69BE4F25}"/>
          </ac:picMkLst>
        </pc:picChg>
        <pc:picChg chg="add mod">
          <ac:chgData name="Joshi, Aniket Sunil" userId="99c22df6-eccd-47fd-9b08-c584eb42b50d" providerId="ADAL" clId="{7E24928D-0DA9-4F6A-A7A9-B24B17E80209}" dt="2025-08-22T22:58:08.027" v="5" actId="1076"/>
          <ac:picMkLst>
            <pc:docMk/>
            <pc:sldMk cId="1484563804" sldId="256"/>
            <ac:picMk id="70" creationId="{B7BEC691-4DDA-4404-900F-36DBA2DC0867}"/>
          </ac:picMkLst>
        </pc:picChg>
        <pc:picChg chg="add mod">
          <ac:chgData name="Joshi, Aniket Sunil" userId="99c22df6-eccd-47fd-9b08-c584eb42b50d" providerId="ADAL" clId="{7E24928D-0DA9-4F6A-A7A9-B24B17E80209}" dt="2025-08-23T16:59:06.524" v="10" actId="1076"/>
          <ac:picMkLst>
            <pc:docMk/>
            <pc:sldMk cId="1484563804" sldId="256"/>
            <ac:picMk id="83" creationId="{463D44D3-53EF-4B85-8372-0005461D82F1}"/>
          </ac:picMkLst>
        </pc:picChg>
        <pc:cxnChg chg="add mod">
          <ac:chgData name="Joshi, Aniket Sunil" userId="99c22df6-eccd-47fd-9b08-c584eb42b50d" providerId="ADAL" clId="{7E24928D-0DA9-4F6A-A7A9-B24B17E80209}" dt="2025-08-22T22:58:16.481" v="7" actId="1076"/>
          <ac:cxnSpMkLst>
            <pc:docMk/>
            <pc:sldMk cId="1484563804" sldId="256"/>
            <ac:cxnSpMk id="13" creationId="{CEBCF406-E62B-4456-B618-D1F921B46485}"/>
          </ac:cxnSpMkLst>
        </pc:cxnChg>
        <pc:cxnChg chg="add mod">
          <ac:chgData name="Joshi, Aniket Sunil" userId="99c22df6-eccd-47fd-9b08-c584eb42b50d" providerId="ADAL" clId="{7E24928D-0DA9-4F6A-A7A9-B24B17E80209}" dt="2025-08-22T22:58:16.481" v="7" actId="1076"/>
          <ac:cxnSpMkLst>
            <pc:docMk/>
            <pc:sldMk cId="1484563804" sldId="256"/>
            <ac:cxnSpMk id="14" creationId="{5B0AAB07-4AC0-4D96-A8F4-A0C58828C25D}"/>
          </ac:cxnSpMkLst>
        </pc:cxnChg>
        <pc:cxnChg chg="add mod">
          <ac:chgData name="Joshi, Aniket Sunil" userId="99c22df6-eccd-47fd-9b08-c584eb42b50d" providerId="ADAL" clId="{7E24928D-0DA9-4F6A-A7A9-B24B17E80209}" dt="2025-08-22T22:58:16.481" v="7" actId="1076"/>
          <ac:cxnSpMkLst>
            <pc:docMk/>
            <pc:sldMk cId="1484563804" sldId="256"/>
            <ac:cxnSpMk id="15" creationId="{0F84E30E-052E-4456-86F2-1CE41FA51A98}"/>
          </ac:cxnSpMkLst>
        </pc:cxnChg>
        <pc:cxnChg chg="add mod">
          <ac:chgData name="Joshi, Aniket Sunil" userId="99c22df6-eccd-47fd-9b08-c584eb42b50d" providerId="ADAL" clId="{7E24928D-0DA9-4F6A-A7A9-B24B17E80209}" dt="2025-08-22T22:58:16.481" v="7" actId="1076"/>
          <ac:cxnSpMkLst>
            <pc:docMk/>
            <pc:sldMk cId="1484563804" sldId="256"/>
            <ac:cxnSpMk id="16" creationId="{4F51749D-8078-4418-9B3B-7DA8440FBF59}"/>
          </ac:cxnSpMkLst>
        </pc:cxnChg>
        <pc:cxnChg chg="add mod">
          <ac:chgData name="Joshi, Aniket Sunil" userId="99c22df6-eccd-47fd-9b08-c584eb42b50d" providerId="ADAL" clId="{7E24928D-0DA9-4F6A-A7A9-B24B17E80209}" dt="2025-08-22T22:58:16.481" v="7" actId="1076"/>
          <ac:cxnSpMkLst>
            <pc:docMk/>
            <pc:sldMk cId="1484563804" sldId="256"/>
            <ac:cxnSpMk id="21" creationId="{50F7C87C-8A24-4034-9FEC-149011D27512}"/>
          </ac:cxnSpMkLst>
        </pc:cxnChg>
        <pc:cxnChg chg="add mod">
          <ac:chgData name="Joshi, Aniket Sunil" userId="99c22df6-eccd-47fd-9b08-c584eb42b50d" providerId="ADAL" clId="{7E24928D-0DA9-4F6A-A7A9-B24B17E80209}" dt="2025-08-22T22:58:16.481" v="7" actId="1076"/>
          <ac:cxnSpMkLst>
            <pc:docMk/>
            <pc:sldMk cId="1484563804" sldId="256"/>
            <ac:cxnSpMk id="22" creationId="{1ADA1F51-1925-4D6B-9FAE-C8538E093E1E}"/>
          </ac:cxnSpMkLst>
        </pc:cxnChg>
        <pc:cxnChg chg="add mod">
          <ac:chgData name="Joshi, Aniket Sunil" userId="99c22df6-eccd-47fd-9b08-c584eb42b50d" providerId="ADAL" clId="{7E24928D-0DA9-4F6A-A7A9-B24B17E80209}" dt="2025-08-22T22:58:16.481" v="7" actId="1076"/>
          <ac:cxnSpMkLst>
            <pc:docMk/>
            <pc:sldMk cId="1484563804" sldId="256"/>
            <ac:cxnSpMk id="23" creationId="{B358885F-87BC-4AAD-924A-C7173844B382}"/>
          </ac:cxnSpMkLst>
        </pc:cxnChg>
        <pc:cxnChg chg="add mod">
          <ac:chgData name="Joshi, Aniket Sunil" userId="99c22df6-eccd-47fd-9b08-c584eb42b50d" providerId="ADAL" clId="{7E24928D-0DA9-4F6A-A7A9-B24B17E80209}" dt="2025-08-22T22:58:16.481" v="7" actId="1076"/>
          <ac:cxnSpMkLst>
            <pc:docMk/>
            <pc:sldMk cId="1484563804" sldId="256"/>
            <ac:cxnSpMk id="24" creationId="{827EBCDD-DB6B-40A4-9B51-C1066E9E9015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33" creationId="{E8422BF5-70F8-4FF3-8307-9444BAF1577E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34" creationId="{994A3B8E-EFF2-427A-A0A7-3434C1877E88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35" creationId="{FD271183-558B-4BCC-AAFA-D16E9D25F4EC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36" creationId="{6783F180-774C-4470-86CD-DB8C5889BE24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41" creationId="{3407F5F9-2F39-4604-A0AC-68312C8ADE40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42" creationId="{23ADA4A4-DEF1-4E3C-8556-2CF678FB47B2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43" creationId="{F5DB4F3C-BB48-4417-896A-C352DA7104A3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44" creationId="{480549AB-C784-4E0C-88A9-F75EFD577B33}"/>
          </ac:cxnSpMkLst>
        </pc:cxnChg>
        <pc:cxnChg chg="add mod">
          <ac:chgData name="Joshi, Aniket Sunil" userId="99c22df6-eccd-47fd-9b08-c584eb42b50d" providerId="ADAL" clId="{7E24928D-0DA9-4F6A-A7A9-B24B17E80209}" dt="2025-08-23T16:59:11.050" v="11" actId="1076"/>
          <ac:cxnSpMkLst>
            <pc:docMk/>
            <pc:sldMk cId="1484563804" sldId="256"/>
            <ac:cxnSpMk id="57" creationId="{559553FD-CBE6-4CEA-A722-4C9DE673B5CC}"/>
          </ac:cxnSpMkLst>
        </pc:cxnChg>
        <pc:cxnChg chg="add mod">
          <ac:chgData name="Joshi, Aniket Sunil" userId="99c22df6-eccd-47fd-9b08-c584eb42b50d" providerId="ADAL" clId="{7E24928D-0DA9-4F6A-A7A9-B24B17E80209}" dt="2025-08-23T16:59:11.050" v="11" actId="1076"/>
          <ac:cxnSpMkLst>
            <pc:docMk/>
            <pc:sldMk cId="1484563804" sldId="256"/>
            <ac:cxnSpMk id="59" creationId="{2608F872-5C8D-4738-B6F3-F764CF797399}"/>
          </ac:cxnSpMkLst>
        </pc:cxnChg>
        <pc:cxnChg chg="add mod">
          <ac:chgData name="Joshi, Aniket Sunil" userId="99c22df6-eccd-47fd-9b08-c584eb42b50d" providerId="ADAL" clId="{7E24928D-0DA9-4F6A-A7A9-B24B17E80209}" dt="2025-08-23T16:59:11.050" v="11" actId="1076"/>
          <ac:cxnSpMkLst>
            <pc:docMk/>
            <pc:sldMk cId="1484563804" sldId="256"/>
            <ac:cxnSpMk id="61" creationId="{4E03CD72-257D-4084-AEF0-4CC8396ECCB5}"/>
          </ac:cxnSpMkLst>
        </pc:cxnChg>
        <pc:cxnChg chg="add mod">
          <ac:chgData name="Joshi, Aniket Sunil" userId="99c22df6-eccd-47fd-9b08-c584eb42b50d" providerId="ADAL" clId="{7E24928D-0DA9-4F6A-A7A9-B24B17E80209}" dt="2025-08-22T22:58:08.027" v="5" actId="1076"/>
          <ac:cxnSpMkLst>
            <pc:docMk/>
            <pc:sldMk cId="1484563804" sldId="256"/>
            <ac:cxnSpMk id="72" creationId="{516A0491-4983-413F-B037-38633EAC575C}"/>
          </ac:cxnSpMkLst>
        </pc:cxnChg>
        <pc:cxnChg chg="add mod">
          <ac:chgData name="Joshi, Aniket Sunil" userId="99c22df6-eccd-47fd-9b08-c584eb42b50d" providerId="ADAL" clId="{7E24928D-0DA9-4F6A-A7A9-B24B17E80209}" dt="2025-08-22T22:58:08.027" v="5" actId="1076"/>
          <ac:cxnSpMkLst>
            <pc:docMk/>
            <pc:sldMk cId="1484563804" sldId="256"/>
            <ac:cxnSpMk id="73" creationId="{FC1680AC-CD91-4791-9AE9-E0DCA3BD52AC}"/>
          </ac:cxnSpMkLst>
        </pc:cxnChg>
        <pc:cxnChg chg="add mod">
          <ac:chgData name="Joshi, Aniket Sunil" userId="99c22df6-eccd-47fd-9b08-c584eb42b50d" providerId="ADAL" clId="{7E24928D-0DA9-4F6A-A7A9-B24B17E80209}" dt="2025-08-22T22:58:08.027" v="5" actId="1076"/>
          <ac:cxnSpMkLst>
            <pc:docMk/>
            <pc:sldMk cId="1484563804" sldId="256"/>
            <ac:cxnSpMk id="75" creationId="{DF1FB03A-1BEF-4CA3-94A6-9393FB0D8607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85" creationId="{09FB2770-0BE5-4B46-BB86-774289C73F8D}"/>
          </ac:cxnSpMkLst>
        </pc:cxnChg>
        <pc:cxnChg chg="add mod">
          <ac:chgData name="Joshi, Aniket Sunil" userId="99c22df6-eccd-47fd-9b08-c584eb42b50d" providerId="ADAL" clId="{7E24928D-0DA9-4F6A-A7A9-B24B17E80209}" dt="2025-08-23T16:59:06.524" v="10" actId="1076"/>
          <ac:cxnSpMkLst>
            <pc:docMk/>
            <pc:sldMk cId="1484563804" sldId="256"/>
            <ac:cxnSpMk id="86" creationId="{2F4E2D00-D440-4FB2-BB07-CEA66C48F226}"/>
          </ac:cxnSpMkLst>
        </pc:cxnChg>
        <pc:cxnChg chg="add mod">
          <ac:chgData name="Joshi, Aniket Sunil" userId="99c22df6-eccd-47fd-9b08-c584eb42b50d" providerId="ADAL" clId="{7E24928D-0DA9-4F6A-A7A9-B24B17E80209}" dt="2025-08-23T16:59:26.529" v="15" actId="1076"/>
          <ac:cxnSpMkLst>
            <pc:docMk/>
            <pc:sldMk cId="1484563804" sldId="256"/>
            <ac:cxnSpMk id="88" creationId="{DA3E6245-CFC5-40B6-8400-25125ECD2A51}"/>
          </ac:cxnSpMkLst>
        </pc:cxnChg>
        <pc:cxnChg chg="add mod">
          <ac:chgData name="Joshi, Aniket Sunil" userId="99c22df6-eccd-47fd-9b08-c584eb42b50d" providerId="ADAL" clId="{7E24928D-0DA9-4F6A-A7A9-B24B17E80209}" dt="2025-08-23T16:59:23.821" v="14" actId="1076"/>
          <ac:cxnSpMkLst>
            <pc:docMk/>
            <pc:sldMk cId="1484563804" sldId="256"/>
            <ac:cxnSpMk id="89" creationId="{B4744B8D-1848-4BDE-9A2A-2C392B4EAD31}"/>
          </ac:cxnSpMkLst>
        </pc:cxnChg>
        <pc:cxnChg chg="add mod">
          <ac:chgData name="Joshi, Aniket Sunil" userId="99c22df6-eccd-47fd-9b08-c584eb42b50d" providerId="ADAL" clId="{7E24928D-0DA9-4F6A-A7A9-B24B17E80209}" dt="2025-08-23T16:59:21.430" v="13" actId="1076"/>
          <ac:cxnSpMkLst>
            <pc:docMk/>
            <pc:sldMk cId="1484563804" sldId="256"/>
            <ac:cxnSpMk id="90" creationId="{EF4C8B17-6965-457E-B5BC-CAF21330A228}"/>
          </ac:cxnSpMkLst>
        </pc:cxnChg>
        <pc:cxnChg chg="add mod">
          <ac:chgData name="Joshi, Aniket Sunil" userId="99c22df6-eccd-47fd-9b08-c584eb42b50d" providerId="ADAL" clId="{7E24928D-0DA9-4F6A-A7A9-B24B17E80209}" dt="2025-08-23T16:59:45.511" v="22" actId="1035"/>
          <ac:cxnSpMkLst>
            <pc:docMk/>
            <pc:sldMk cId="1484563804" sldId="256"/>
            <ac:cxnSpMk id="91" creationId="{F1BB46DB-7D36-451A-B328-C85D5CE3551E}"/>
          </ac:cxnSpMkLst>
        </pc:cxnChg>
        <pc:cxnChg chg="add mod">
          <ac:chgData name="Joshi, Aniket Sunil" userId="99c22df6-eccd-47fd-9b08-c584eb42b50d" providerId="ADAL" clId="{7E24928D-0DA9-4F6A-A7A9-B24B17E80209}" dt="2025-08-23T16:59:38.761" v="19" actId="1035"/>
          <ac:cxnSpMkLst>
            <pc:docMk/>
            <pc:sldMk cId="1484563804" sldId="256"/>
            <ac:cxnSpMk id="92" creationId="{99311880-AF0F-4C78-A8BA-7CEC13A67D27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DBF688-9657-45D3-BD86-2D72518B284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575A7B8-375A-405D-8445-A83D87A076F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EC3E44-6C2E-44D0-97FD-9B6ECC648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37E796-B2A2-4B8F-BF98-F5BA2C06A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F84454-72B7-4124-8E87-994A897367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46019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0651EC-C658-4A34-9AE5-047F77CD0C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2822BBD-9DEA-45DB-AE2A-A272E1B4CD2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AE2232-10FF-4FDE-A621-4A4E233703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0069BC-65D8-4FB3-9617-4528AE43B9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43B62-3777-44C9-9947-37B06D14D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8882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E681B9-2B8D-438C-BEE0-3ADCD2D2FA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970CB2A-795A-4F30-AE54-6A5634C456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55CB0A-1B88-488C-ACAE-1942AEA381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FA2E1E-A40D-4E39-BF73-435DEC4279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67210A-1563-4489-9496-DB4D817CDF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94465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3C7D56-BC7C-43F8-84EF-FF20DEA9D7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94303A-B9DC-4317-AF45-42AB939D3E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8F3475-B58A-4FFF-AB60-5C7189C26E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5F858B-6A62-4F02-9214-3FE852700D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3AD0CA-B9F2-4133-9FD9-1C53D7C26F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065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72ADF-FB39-4CDE-9701-CF1FA3054D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DE9883-C8B0-4470-97B1-E96A35AC80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F81A1C-A9E2-4AFD-99BB-8233228553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EF6528-FF72-42DD-A1F5-2E28DD280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7EDE1E-0B75-40B8-8923-FD42F0A8A0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8520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F2048-5DCE-4792-B15D-D8EC2C2256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4053B1-1E66-42AB-B113-5B5CE3176E8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E513B4-CF23-4FA5-A019-69DE8BD992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FB5E45-E677-4262-BE59-CE6883D67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D9D940B-EA74-48B3-ABDC-A262DE0AAB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AFBB3D-B37F-4C54-A3D1-C91E886DC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27176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2A4F76-ED6A-467A-8E60-F41856383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9F8EC1F-1E80-43C7-BF83-2267F52D81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B8DE27E-5BB6-4B8C-A652-0CB8F1BBE21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8DC2053-F242-4BC9-AAD3-B8BCD0F885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533909-F98D-45B0-8C69-CA9485A64C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8184B89-737B-45F7-8A69-8192684424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766794-EBC1-459B-A611-BA6162489E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498234-8F18-4D70-8273-005C1332F0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0235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E15B93-0BBB-4913-BC52-C8F4E02B4B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AF65836-1BE0-4E7F-81FE-8C12FFBA2F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5D52A30-D77E-47B1-8BC9-06CB9D8CE7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F7886E-F81B-42D2-A26C-C50D9475E0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8178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76AD4D2-BC79-4414-9963-D3107610CD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361186B-A017-4D1A-9D81-44DED5978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1F4D65-A95C-4E9D-8106-785E20291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260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39B82D-B75B-4E16-8827-C476733880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2DDFEE-793B-4AB5-8B68-58685A1C30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0234C2A-823F-4FDD-AAB9-4410CD78CC2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DAB657-7F25-4A9C-B5A2-44B9018148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10DB53-3EBA-4552-95A9-20AA27D74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3CB63A9-5BAD-40BE-9949-C78BE83B54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5247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ED964A-A412-444A-BF31-5A3BA9002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09D02C3-EBC5-4F49-A8D3-6F79DAD35C3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6BE458A-C493-4E82-9ED8-25CF600942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0353BF2-C94A-4C95-984F-B0A828B12F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09931CF-AC49-46C2-9ED2-5B26F9CA9E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84E314-0CA8-45DB-9F5B-4A8F43ED78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561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637887C-8F1B-4C15-87FB-FF7C07CFDA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35BFD4-577D-4AC5-936F-F865497320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DE3769E-E5F2-48CD-8CC4-44FF321A56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CBA54F-D47F-4B1F-92C6-775F4AFE1D2A}" type="datetimeFigureOut">
              <a:rPr lang="en-US" smtClean="0"/>
              <a:t>8/23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6DDABF-4504-4D12-8A37-323B72E142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E65043-F923-4C52-A479-6A0747E8025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986DD-E004-4846-BBD5-7FA87F3BCF9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6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8.png"/><Relationship Id="rId18" Type="http://schemas.openxmlformats.org/officeDocument/2006/relationships/image" Target="../media/image11.png"/><Relationship Id="rId3" Type="http://schemas.microsoft.com/office/2007/relationships/hdphoto" Target="../media/hdphoto1.wdp"/><Relationship Id="rId21" Type="http://schemas.microsoft.com/office/2007/relationships/hdphoto" Target="../media/hdphoto8.wdp"/><Relationship Id="rId7" Type="http://schemas.microsoft.com/office/2007/relationships/hdphoto" Target="../media/hdphoto3.wdp"/><Relationship Id="rId12" Type="http://schemas.openxmlformats.org/officeDocument/2006/relationships/image" Target="../media/image7.png"/><Relationship Id="rId17" Type="http://schemas.openxmlformats.org/officeDocument/2006/relationships/image" Target="../media/image10.png"/><Relationship Id="rId25" Type="http://schemas.microsoft.com/office/2007/relationships/hdphoto" Target="../media/hdphoto10.wdp"/><Relationship Id="rId2" Type="http://schemas.openxmlformats.org/officeDocument/2006/relationships/image" Target="../media/image1.png"/><Relationship Id="rId16" Type="http://schemas.microsoft.com/office/2007/relationships/hdphoto" Target="../media/hdphoto6.wdp"/><Relationship Id="rId20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6.png"/><Relationship Id="rId24" Type="http://schemas.openxmlformats.org/officeDocument/2006/relationships/image" Target="../media/image14.png"/><Relationship Id="rId5" Type="http://schemas.microsoft.com/office/2007/relationships/hdphoto" Target="../media/hdphoto2.wdp"/><Relationship Id="rId15" Type="http://schemas.openxmlformats.org/officeDocument/2006/relationships/image" Target="../media/image9.png"/><Relationship Id="rId23" Type="http://schemas.microsoft.com/office/2007/relationships/hdphoto" Target="../media/hdphoto9.wdp"/><Relationship Id="rId10" Type="http://schemas.microsoft.com/office/2007/relationships/hdphoto" Target="../media/hdphoto4.wdp"/><Relationship Id="rId19" Type="http://schemas.microsoft.com/office/2007/relationships/hdphoto" Target="../media/hdphoto7.wdp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microsoft.com/office/2007/relationships/hdphoto" Target="../media/hdphoto5.wdp"/><Relationship Id="rId22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DED6EB2-4FE7-4241-895C-7193506CCC1E}"/>
              </a:ext>
            </a:extLst>
          </p:cNvPr>
          <p:cNvSpPr txBox="1"/>
          <p:nvPr/>
        </p:nvSpPr>
        <p:spPr>
          <a:xfrm>
            <a:off x="306102" y="248402"/>
            <a:ext cx="82266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7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29D2CC-6A17-478F-9075-6DB9BBC3251D}"/>
              </a:ext>
            </a:extLst>
          </p:cNvPr>
          <p:cNvSpPr txBox="1"/>
          <p:nvPr/>
        </p:nvSpPr>
        <p:spPr>
          <a:xfrm>
            <a:off x="1687990" y="2115637"/>
            <a:ext cx="757122" cy="245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Fbxo3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8D5F5F9-ED3F-45A8-830A-B7995E450D80}"/>
              </a:ext>
            </a:extLst>
          </p:cNvPr>
          <p:cNvSpPr txBox="1"/>
          <p:nvPr/>
        </p:nvSpPr>
        <p:spPr>
          <a:xfrm>
            <a:off x="1687990" y="4328510"/>
            <a:ext cx="560075" cy="245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Atg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B902153-BC1C-481D-8C89-C166AA78B674}"/>
              </a:ext>
            </a:extLst>
          </p:cNvPr>
          <p:cNvSpPr txBox="1"/>
          <p:nvPr/>
        </p:nvSpPr>
        <p:spPr>
          <a:xfrm>
            <a:off x="1739265" y="3176508"/>
            <a:ext cx="880979" cy="245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Map1lc3b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74C75CFF-70A3-48C2-ACAC-6B079A5293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855" t="29471" r="15829" b="15199"/>
          <a:stretch/>
        </p:blipFill>
        <p:spPr>
          <a:xfrm>
            <a:off x="749014" y="3558732"/>
            <a:ext cx="968348" cy="113152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CB2479B-4B6A-4B67-AF20-3884C736C29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336" t="21381" r="21098" b="17264"/>
          <a:stretch/>
        </p:blipFill>
        <p:spPr>
          <a:xfrm>
            <a:off x="680772" y="1387863"/>
            <a:ext cx="1036590" cy="10725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D51010E4-F6FA-4AA2-833B-25B2AA67144B}"/>
              </a:ext>
            </a:extLst>
          </p:cNvPr>
          <p:cNvSpPr txBox="1"/>
          <p:nvPr/>
        </p:nvSpPr>
        <p:spPr>
          <a:xfrm>
            <a:off x="1687990" y="5266978"/>
            <a:ext cx="574612" cy="245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Xbp1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3207B1D6-FA09-450D-A596-1BBA25C2860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517" t="40791" r="19271" b="20886"/>
          <a:stretch/>
        </p:blipFill>
        <p:spPr>
          <a:xfrm>
            <a:off x="661645" y="4747940"/>
            <a:ext cx="1055718" cy="8178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894B1E65-C782-4907-89F0-B508DB4F68CE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68" t="25136" r="18209" b="13926"/>
          <a:stretch/>
        </p:blipFill>
        <p:spPr>
          <a:xfrm>
            <a:off x="749014" y="2553099"/>
            <a:ext cx="968348" cy="95301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CEBCF406-E62B-4456-B618-D1F921B46485}"/>
              </a:ext>
            </a:extLst>
          </p:cNvPr>
          <p:cNvCxnSpPr/>
          <p:nvPr/>
        </p:nvCxnSpPr>
        <p:spPr>
          <a:xfrm>
            <a:off x="600655" y="4572462"/>
            <a:ext cx="26085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5B0AAB07-4AC0-4D96-A8F4-A0C58828C25D}"/>
              </a:ext>
            </a:extLst>
          </p:cNvPr>
          <p:cNvCxnSpPr/>
          <p:nvPr/>
        </p:nvCxnSpPr>
        <p:spPr>
          <a:xfrm>
            <a:off x="626223" y="3361143"/>
            <a:ext cx="26085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0F84E30E-052E-4456-86F2-1CE41FA51A98}"/>
              </a:ext>
            </a:extLst>
          </p:cNvPr>
          <p:cNvCxnSpPr/>
          <p:nvPr/>
        </p:nvCxnSpPr>
        <p:spPr>
          <a:xfrm>
            <a:off x="600655" y="2350259"/>
            <a:ext cx="26085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4F51749D-8078-4418-9B3B-7DA8440FBF59}"/>
              </a:ext>
            </a:extLst>
          </p:cNvPr>
          <p:cNvCxnSpPr/>
          <p:nvPr/>
        </p:nvCxnSpPr>
        <p:spPr>
          <a:xfrm>
            <a:off x="600655" y="5457000"/>
            <a:ext cx="26085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26A3A7E8-0D20-4790-BDDA-1121691F0E70}"/>
              </a:ext>
            </a:extLst>
          </p:cNvPr>
          <p:cNvSpPr txBox="1"/>
          <p:nvPr/>
        </p:nvSpPr>
        <p:spPr>
          <a:xfrm>
            <a:off x="283250" y="2199795"/>
            <a:ext cx="419674" cy="245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F62A1EA-EEE3-4222-9DB7-F3539D66B5AD}"/>
              </a:ext>
            </a:extLst>
          </p:cNvPr>
          <p:cNvSpPr txBox="1"/>
          <p:nvPr/>
        </p:nvSpPr>
        <p:spPr>
          <a:xfrm>
            <a:off x="290451" y="3213746"/>
            <a:ext cx="419674" cy="245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797F082-C531-4F7E-AB70-111A80B07E96}"/>
              </a:ext>
            </a:extLst>
          </p:cNvPr>
          <p:cNvSpPr txBox="1"/>
          <p:nvPr/>
        </p:nvSpPr>
        <p:spPr>
          <a:xfrm>
            <a:off x="266889" y="4436095"/>
            <a:ext cx="419674" cy="245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C1E817D-3DB4-4AB9-9C3B-65C418A7E6A6}"/>
              </a:ext>
            </a:extLst>
          </p:cNvPr>
          <p:cNvSpPr txBox="1"/>
          <p:nvPr/>
        </p:nvSpPr>
        <p:spPr>
          <a:xfrm>
            <a:off x="273406" y="5327331"/>
            <a:ext cx="419674" cy="245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0F7C87C-8A24-4034-9FEC-149011D27512}"/>
              </a:ext>
            </a:extLst>
          </p:cNvPr>
          <p:cNvCxnSpPr/>
          <p:nvPr/>
        </p:nvCxnSpPr>
        <p:spPr>
          <a:xfrm>
            <a:off x="1659712" y="4564021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ADA1F51-1925-4D6B-9FAE-C8538E093E1E}"/>
              </a:ext>
            </a:extLst>
          </p:cNvPr>
          <p:cNvCxnSpPr/>
          <p:nvPr/>
        </p:nvCxnSpPr>
        <p:spPr>
          <a:xfrm>
            <a:off x="1617099" y="3394905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358885F-87BC-4AAD-924A-C7173844B382}"/>
              </a:ext>
            </a:extLst>
          </p:cNvPr>
          <p:cNvCxnSpPr/>
          <p:nvPr/>
        </p:nvCxnSpPr>
        <p:spPr>
          <a:xfrm>
            <a:off x="1659712" y="2367140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827EBCDD-DB6B-40A4-9B51-C1066E9E9015}"/>
              </a:ext>
            </a:extLst>
          </p:cNvPr>
          <p:cNvCxnSpPr/>
          <p:nvPr/>
        </p:nvCxnSpPr>
        <p:spPr>
          <a:xfrm>
            <a:off x="1659712" y="5490761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5" name="Picture 24">
            <a:extLst>
              <a:ext uri="{FF2B5EF4-FFF2-40B4-BE49-F238E27FC236}">
                <a16:creationId xmlns:a16="http://schemas.microsoft.com/office/drawing/2014/main" id="{97A1CAAD-E5B7-417A-BE39-47524B601CA6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733" t="7047" r="5442" b="6539"/>
          <a:stretch/>
        </p:blipFill>
        <p:spPr>
          <a:xfrm>
            <a:off x="6713501" y="3458706"/>
            <a:ext cx="1133180" cy="960493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980D749E-AB2B-4C67-96C2-74EB7FD659AE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9" t="8110" r="14345" b="14455"/>
          <a:stretch/>
        </p:blipFill>
        <p:spPr>
          <a:xfrm>
            <a:off x="6703962" y="2311347"/>
            <a:ext cx="1043119" cy="1064282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6E866DCE-B217-484B-B21D-26CF5AA77183}"/>
              </a:ext>
            </a:extLst>
          </p:cNvPr>
          <p:cNvSpPr txBox="1"/>
          <p:nvPr/>
        </p:nvSpPr>
        <p:spPr>
          <a:xfrm>
            <a:off x="7871301" y="3885495"/>
            <a:ext cx="5703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Il-6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6972856-DB0C-485D-8600-461ACF39A815}"/>
              </a:ext>
            </a:extLst>
          </p:cNvPr>
          <p:cNvSpPr txBox="1"/>
          <p:nvPr/>
        </p:nvSpPr>
        <p:spPr>
          <a:xfrm>
            <a:off x="7790901" y="2849735"/>
            <a:ext cx="643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Xbp1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04426669-5056-4AB6-8651-8837B9E38122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97" t="20663" r="14058" b="1689"/>
          <a:stretch/>
        </p:blipFill>
        <p:spPr>
          <a:xfrm>
            <a:off x="6703962" y="1302582"/>
            <a:ext cx="1043119" cy="9192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05A64AF2-2944-4B10-89C2-5B6CE0550E3D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702" t="10755" r="20436" b="28707"/>
          <a:stretch/>
        </p:blipFill>
        <p:spPr>
          <a:xfrm>
            <a:off x="6703962" y="4498362"/>
            <a:ext cx="1133180" cy="875731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46EE717D-9F4B-4D9A-9796-5F8AA64A4132}"/>
              </a:ext>
            </a:extLst>
          </p:cNvPr>
          <p:cNvSpPr txBox="1"/>
          <p:nvPr/>
        </p:nvSpPr>
        <p:spPr>
          <a:xfrm>
            <a:off x="7817783" y="5002647"/>
            <a:ext cx="623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Pdk4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7B88072-5863-41D3-855F-72B6CB7A665E}"/>
              </a:ext>
            </a:extLst>
          </p:cNvPr>
          <p:cNvSpPr txBox="1"/>
          <p:nvPr/>
        </p:nvSpPr>
        <p:spPr>
          <a:xfrm>
            <a:off x="6207238" y="249997"/>
            <a:ext cx="8354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7G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E8422BF5-70F8-4FF3-8307-9444BAF1577E}"/>
              </a:ext>
            </a:extLst>
          </p:cNvPr>
          <p:cNvCxnSpPr/>
          <p:nvPr/>
        </p:nvCxnSpPr>
        <p:spPr>
          <a:xfrm>
            <a:off x="6593511" y="3973538"/>
            <a:ext cx="240943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994A3B8E-EFF2-427A-A0A7-3434C1877E88}"/>
              </a:ext>
            </a:extLst>
          </p:cNvPr>
          <p:cNvCxnSpPr/>
          <p:nvPr/>
        </p:nvCxnSpPr>
        <p:spPr>
          <a:xfrm>
            <a:off x="6622086" y="3067466"/>
            <a:ext cx="240943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FD271183-558B-4BCC-AAFA-D16E9D25F4EC}"/>
              </a:ext>
            </a:extLst>
          </p:cNvPr>
          <p:cNvCxnSpPr/>
          <p:nvPr/>
        </p:nvCxnSpPr>
        <p:spPr>
          <a:xfrm>
            <a:off x="6593511" y="1737555"/>
            <a:ext cx="240943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6783F180-774C-4470-86CD-DB8C5889BE24}"/>
              </a:ext>
            </a:extLst>
          </p:cNvPr>
          <p:cNvCxnSpPr/>
          <p:nvPr/>
        </p:nvCxnSpPr>
        <p:spPr>
          <a:xfrm>
            <a:off x="6593511" y="5246793"/>
            <a:ext cx="240943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46C5BF2-4420-46B7-AF3A-E358C46E7A83}"/>
              </a:ext>
            </a:extLst>
          </p:cNvPr>
          <p:cNvSpPr txBox="1"/>
          <p:nvPr/>
        </p:nvSpPr>
        <p:spPr>
          <a:xfrm>
            <a:off x="6245146" y="1567758"/>
            <a:ext cx="469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B6132ACC-054C-493E-A9C8-E3C036E652D1}"/>
              </a:ext>
            </a:extLst>
          </p:cNvPr>
          <p:cNvSpPr txBox="1"/>
          <p:nvPr/>
        </p:nvSpPr>
        <p:spPr>
          <a:xfrm>
            <a:off x="6253194" y="2901129"/>
            <a:ext cx="469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81027C7E-EC5B-41DD-9B43-C08967F316CC}"/>
              </a:ext>
            </a:extLst>
          </p:cNvPr>
          <p:cNvSpPr txBox="1"/>
          <p:nvPr/>
        </p:nvSpPr>
        <p:spPr>
          <a:xfrm>
            <a:off x="6226860" y="3819649"/>
            <a:ext cx="469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4B1CEB5-C501-4BF6-B98B-4FBAB7A4DA7F}"/>
              </a:ext>
            </a:extLst>
          </p:cNvPr>
          <p:cNvSpPr txBox="1"/>
          <p:nvPr/>
        </p:nvSpPr>
        <p:spPr>
          <a:xfrm>
            <a:off x="6225598" y="5100463"/>
            <a:ext cx="469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3407F5F9-2F39-4604-A0AC-68312C8ADE40}"/>
              </a:ext>
            </a:extLst>
          </p:cNvPr>
          <p:cNvCxnSpPr/>
          <p:nvPr/>
        </p:nvCxnSpPr>
        <p:spPr>
          <a:xfrm>
            <a:off x="7800426" y="4142311"/>
            <a:ext cx="426846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23ADA4A4-DEF1-4E3C-8556-2CF678FB47B2}"/>
              </a:ext>
            </a:extLst>
          </p:cNvPr>
          <p:cNvCxnSpPr/>
          <p:nvPr/>
        </p:nvCxnSpPr>
        <p:spPr>
          <a:xfrm>
            <a:off x="7729615" y="3143475"/>
            <a:ext cx="426846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F5DB4F3C-BB48-4417-896A-C352DA7104A3}"/>
              </a:ext>
            </a:extLst>
          </p:cNvPr>
          <p:cNvCxnSpPr/>
          <p:nvPr/>
        </p:nvCxnSpPr>
        <p:spPr>
          <a:xfrm>
            <a:off x="7729615" y="1949050"/>
            <a:ext cx="426846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480549AB-C784-4E0C-88A9-F75EFD577B33}"/>
              </a:ext>
            </a:extLst>
          </p:cNvPr>
          <p:cNvCxnSpPr/>
          <p:nvPr/>
        </p:nvCxnSpPr>
        <p:spPr>
          <a:xfrm>
            <a:off x="7767587" y="5256124"/>
            <a:ext cx="426846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F3EE5B06-791E-40B7-BB90-2AFB929EFF0C}"/>
              </a:ext>
            </a:extLst>
          </p:cNvPr>
          <p:cNvSpPr txBox="1"/>
          <p:nvPr/>
        </p:nvSpPr>
        <p:spPr>
          <a:xfrm>
            <a:off x="7767587" y="1675475"/>
            <a:ext cx="8102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Fbxo32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ECD1D96B-DDEC-4DF1-977D-75A57A494CDE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819" t="33365" r="17604" b="10283"/>
          <a:stretch/>
        </p:blipFill>
        <p:spPr>
          <a:xfrm>
            <a:off x="3348139" y="3746949"/>
            <a:ext cx="1243091" cy="10865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1A70EF27-47CE-4DA3-8919-37AD1C2CE086}"/>
              </a:ext>
            </a:extLst>
          </p:cNvPr>
          <p:cNvSpPr txBox="1"/>
          <p:nvPr/>
        </p:nvSpPr>
        <p:spPr>
          <a:xfrm>
            <a:off x="4604038" y="4136542"/>
            <a:ext cx="854614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Hspa5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614EA8C-3B83-4644-A1CF-66A118429C0F}"/>
              </a:ext>
            </a:extLst>
          </p:cNvPr>
          <p:cNvSpPr txBox="1"/>
          <p:nvPr/>
        </p:nvSpPr>
        <p:spPr>
          <a:xfrm>
            <a:off x="4610005" y="2115380"/>
            <a:ext cx="610144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Rpl30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2EE764C-370A-4BED-80A0-2DE71C2CF1BD}"/>
              </a:ext>
            </a:extLst>
          </p:cNvPr>
          <p:cNvSpPr txBox="1"/>
          <p:nvPr/>
        </p:nvSpPr>
        <p:spPr>
          <a:xfrm>
            <a:off x="4604038" y="3026867"/>
            <a:ext cx="854614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Dnajb9</a:t>
            </a: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ADBD84E0-F5E3-4FC0-9696-E34C88DB51C1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72" t="37428" r="31030" b="12025"/>
          <a:stretch/>
        </p:blipFill>
        <p:spPr>
          <a:xfrm>
            <a:off x="3367894" y="1449070"/>
            <a:ext cx="1223336" cy="108714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6338764D-0020-494B-A11C-999865E7F390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9484" t="28635" r="27227" b="25333"/>
          <a:stretch/>
        </p:blipFill>
        <p:spPr>
          <a:xfrm>
            <a:off x="3367894" y="2599903"/>
            <a:ext cx="1223336" cy="10871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2" name="TextBox 51">
            <a:extLst>
              <a:ext uri="{FF2B5EF4-FFF2-40B4-BE49-F238E27FC236}">
                <a16:creationId xmlns:a16="http://schemas.microsoft.com/office/drawing/2014/main" id="{DC1DD82B-85D5-400C-A24F-BBC66218520C}"/>
              </a:ext>
            </a:extLst>
          </p:cNvPr>
          <p:cNvSpPr txBox="1"/>
          <p:nvPr/>
        </p:nvSpPr>
        <p:spPr>
          <a:xfrm rot="1852528">
            <a:off x="3755729" y="634740"/>
            <a:ext cx="348069" cy="81891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11F2621-A065-407F-8385-A51947F4D4DF}"/>
              </a:ext>
            </a:extLst>
          </p:cNvPr>
          <p:cNvSpPr txBox="1"/>
          <p:nvPr/>
        </p:nvSpPr>
        <p:spPr>
          <a:xfrm rot="1852528">
            <a:off x="4061216" y="270589"/>
            <a:ext cx="348069" cy="121083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l-G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Control IgG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B9FEE9B-FCA3-423D-AD74-B2008405EA45}"/>
              </a:ext>
            </a:extLst>
          </p:cNvPr>
          <p:cNvSpPr txBox="1"/>
          <p:nvPr/>
        </p:nvSpPr>
        <p:spPr>
          <a:xfrm rot="1852528">
            <a:off x="4227728" y="547183"/>
            <a:ext cx="348069" cy="91314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-sXBP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22FE1BC-A046-4220-BFFF-63B3642916D0}"/>
              </a:ext>
            </a:extLst>
          </p:cNvPr>
          <p:cNvSpPr txBox="1"/>
          <p:nvPr/>
        </p:nvSpPr>
        <p:spPr>
          <a:xfrm rot="1852528">
            <a:off x="4492823" y="428737"/>
            <a:ext cx="369332" cy="104562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l-G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Histone H3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D9F12BAB-450F-4D74-84E1-44E1ED5980DE}"/>
              </a:ext>
            </a:extLst>
          </p:cNvPr>
          <p:cNvSpPr txBox="1"/>
          <p:nvPr/>
        </p:nvSpPr>
        <p:spPr>
          <a:xfrm>
            <a:off x="3042823" y="348973"/>
            <a:ext cx="8114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7E</a:t>
            </a:r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559553FD-CBE6-4CEA-A722-4C9DE673B5CC}"/>
              </a:ext>
            </a:extLst>
          </p:cNvPr>
          <p:cNvCxnSpPr/>
          <p:nvPr/>
        </p:nvCxnSpPr>
        <p:spPr>
          <a:xfrm>
            <a:off x="3242221" y="2345723"/>
            <a:ext cx="24977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FAB97107-4BE7-47EA-9326-77892F2E7AB9}"/>
              </a:ext>
            </a:extLst>
          </p:cNvPr>
          <p:cNvSpPr txBox="1"/>
          <p:nvPr/>
        </p:nvSpPr>
        <p:spPr>
          <a:xfrm>
            <a:off x="2879607" y="2191708"/>
            <a:ext cx="442035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</a:p>
        </p:txBody>
      </p:sp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2608F872-5C8D-4738-B6F3-F764CF797399}"/>
              </a:ext>
            </a:extLst>
          </p:cNvPr>
          <p:cNvCxnSpPr/>
          <p:nvPr/>
        </p:nvCxnSpPr>
        <p:spPr>
          <a:xfrm>
            <a:off x="3243702" y="3594524"/>
            <a:ext cx="24977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31BA3286-136E-4C2B-8E5E-EC2DB23786FA}"/>
              </a:ext>
            </a:extLst>
          </p:cNvPr>
          <p:cNvSpPr txBox="1"/>
          <p:nvPr/>
        </p:nvSpPr>
        <p:spPr>
          <a:xfrm>
            <a:off x="2890064" y="3459033"/>
            <a:ext cx="442035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4E03CD72-257D-4084-AEF0-4CC8396ECCB5}"/>
              </a:ext>
            </a:extLst>
          </p:cNvPr>
          <p:cNvCxnSpPr/>
          <p:nvPr/>
        </p:nvCxnSpPr>
        <p:spPr>
          <a:xfrm>
            <a:off x="3233245" y="4645372"/>
            <a:ext cx="24977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B485F659-47A1-4AF5-BCD2-B088BAFA9AA6}"/>
              </a:ext>
            </a:extLst>
          </p:cNvPr>
          <p:cNvSpPr txBox="1"/>
          <p:nvPr/>
        </p:nvSpPr>
        <p:spPr>
          <a:xfrm>
            <a:off x="2879607" y="4509881"/>
            <a:ext cx="442035" cy="2564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E9E26707-6F95-4921-B61B-FFC39488FCE4}"/>
              </a:ext>
            </a:extLst>
          </p:cNvPr>
          <p:cNvSpPr txBox="1"/>
          <p:nvPr/>
        </p:nvSpPr>
        <p:spPr>
          <a:xfrm>
            <a:off x="9196209" y="943493"/>
            <a:ext cx="77777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. 7I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0A29198-CCB2-4982-9837-A32C9380FEE1}"/>
              </a:ext>
            </a:extLst>
          </p:cNvPr>
          <p:cNvSpPr txBox="1"/>
          <p:nvPr/>
        </p:nvSpPr>
        <p:spPr>
          <a:xfrm rot="1852528">
            <a:off x="9913628" y="1525644"/>
            <a:ext cx="348660" cy="8082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AD3FC1D6-72ED-49B5-B657-4CA89B7DB449}"/>
              </a:ext>
            </a:extLst>
          </p:cNvPr>
          <p:cNvSpPr txBox="1"/>
          <p:nvPr/>
        </p:nvSpPr>
        <p:spPr>
          <a:xfrm rot="1852528">
            <a:off x="10219633" y="1166212"/>
            <a:ext cx="348660" cy="119513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l-G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Control IgG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086F8E4B-EF2D-423E-8B24-DA01510DBBDA}"/>
              </a:ext>
            </a:extLst>
          </p:cNvPr>
          <p:cNvSpPr txBox="1"/>
          <p:nvPr/>
        </p:nvSpPr>
        <p:spPr>
          <a:xfrm rot="1852528">
            <a:off x="10589020" y="1439221"/>
            <a:ext cx="348660" cy="90130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-sXBP1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773D4EC4-B2A3-405C-A039-1FF223F26203}"/>
              </a:ext>
            </a:extLst>
          </p:cNvPr>
          <p:cNvSpPr txBox="1"/>
          <p:nvPr/>
        </p:nvSpPr>
        <p:spPr>
          <a:xfrm rot="1852528">
            <a:off x="10970892" y="1346957"/>
            <a:ext cx="369332" cy="100555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l-G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Histone H3</a:t>
            </a:r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11B74018-7331-42D8-998A-318B69BE4F25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066" t="11365" r="11862" b="59602"/>
          <a:stretch/>
        </p:blipFill>
        <p:spPr>
          <a:xfrm>
            <a:off x="9585098" y="2330085"/>
            <a:ext cx="1566758" cy="11460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9" name="TextBox 68">
            <a:extLst>
              <a:ext uri="{FF2B5EF4-FFF2-40B4-BE49-F238E27FC236}">
                <a16:creationId xmlns:a16="http://schemas.microsoft.com/office/drawing/2014/main" id="{D46FD904-A4CD-4204-9466-1A4A68794CAC}"/>
              </a:ext>
            </a:extLst>
          </p:cNvPr>
          <p:cNvSpPr txBox="1"/>
          <p:nvPr/>
        </p:nvSpPr>
        <p:spPr>
          <a:xfrm flipH="1">
            <a:off x="11134904" y="2803481"/>
            <a:ext cx="606009" cy="253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Rpl30</a:t>
            </a:r>
          </a:p>
        </p:txBody>
      </p:sp>
      <p:pic>
        <p:nvPicPr>
          <p:cNvPr id="70" name="Picture 69">
            <a:extLst>
              <a:ext uri="{FF2B5EF4-FFF2-40B4-BE49-F238E27FC236}">
                <a16:creationId xmlns:a16="http://schemas.microsoft.com/office/drawing/2014/main" id="{B7BEC691-4DDA-4404-900F-36DBA2DC0867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2248" t="28876" r="-4237" b="17246"/>
          <a:stretch/>
        </p:blipFill>
        <p:spPr>
          <a:xfrm>
            <a:off x="9585098" y="3632369"/>
            <a:ext cx="1335210" cy="112443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1" name="TextBox 70">
            <a:extLst>
              <a:ext uri="{FF2B5EF4-FFF2-40B4-BE49-F238E27FC236}">
                <a16:creationId xmlns:a16="http://schemas.microsoft.com/office/drawing/2014/main" id="{73E02869-B1BE-41D8-87C8-3CBB344DA147}"/>
              </a:ext>
            </a:extLst>
          </p:cNvPr>
          <p:cNvSpPr txBox="1"/>
          <p:nvPr/>
        </p:nvSpPr>
        <p:spPr>
          <a:xfrm>
            <a:off x="10970031" y="4175696"/>
            <a:ext cx="739039" cy="253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Dnajb9</a:t>
            </a:r>
          </a:p>
        </p:txBody>
      </p: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516A0491-4983-413F-B037-38633EAC575C}"/>
              </a:ext>
            </a:extLst>
          </p:cNvPr>
          <p:cNvCxnSpPr/>
          <p:nvPr/>
        </p:nvCxnSpPr>
        <p:spPr>
          <a:xfrm>
            <a:off x="10316662" y="2279800"/>
            <a:ext cx="509607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FC1680AC-CD91-4791-9AE9-E0DCA3BD52AC}"/>
              </a:ext>
            </a:extLst>
          </p:cNvPr>
          <p:cNvCxnSpPr/>
          <p:nvPr/>
        </p:nvCxnSpPr>
        <p:spPr>
          <a:xfrm>
            <a:off x="9457813" y="4636856"/>
            <a:ext cx="20677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>
            <a:extLst>
              <a:ext uri="{FF2B5EF4-FFF2-40B4-BE49-F238E27FC236}">
                <a16:creationId xmlns:a16="http://schemas.microsoft.com/office/drawing/2014/main" id="{E8982295-E0CB-4581-BD5B-55FCA065915A}"/>
              </a:ext>
            </a:extLst>
          </p:cNvPr>
          <p:cNvSpPr txBox="1"/>
          <p:nvPr/>
        </p:nvSpPr>
        <p:spPr>
          <a:xfrm>
            <a:off x="9098783" y="4503122"/>
            <a:ext cx="442785" cy="253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DF1FB03A-1BEF-4CA3-94A6-9393FB0D8607}"/>
              </a:ext>
            </a:extLst>
          </p:cNvPr>
          <p:cNvCxnSpPr/>
          <p:nvPr/>
        </p:nvCxnSpPr>
        <p:spPr>
          <a:xfrm>
            <a:off x="9457813" y="3266208"/>
            <a:ext cx="206779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id="{0EA1369D-7FF4-4EC5-BFCB-11A8AD17A6AF}"/>
              </a:ext>
            </a:extLst>
          </p:cNvPr>
          <p:cNvSpPr txBox="1"/>
          <p:nvPr/>
        </p:nvSpPr>
        <p:spPr>
          <a:xfrm>
            <a:off x="9098783" y="3132474"/>
            <a:ext cx="442785" cy="253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B36E0F33-9408-41F8-9E89-DF185D93C20B}"/>
              </a:ext>
            </a:extLst>
          </p:cNvPr>
          <p:cNvSpPr txBox="1"/>
          <p:nvPr/>
        </p:nvSpPr>
        <p:spPr>
          <a:xfrm rot="1852528">
            <a:off x="1109296" y="568593"/>
            <a:ext cx="348069" cy="81891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8F709D37-FB48-47BB-935E-B07EEA2A5F3D}"/>
              </a:ext>
            </a:extLst>
          </p:cNvPr>
          <p:cNvSpPr txBox="1"/>
          <p:nvPr/>
        </p:nvSpPr>
        <p:spPr>
          <a:xfrm rot="1852528">
            <a:off x="1414783" y="204442"/>
            <a:ext cx="348069" cy="121083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l-G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Control IgG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AACA81AA-629F-4334-93E0-B02D4B87CF9B}"/>
              </a:ext>
            </a:extLst>
          </p:cNvPr>
          <p:cNvSpPr txBox="1"/>
          <p:nvPr/>
        </p:nvSpPr>
        <p:spPr>
          <a:xfrm rot="1852528">
            <a:off x="1581295" y="481036"/>
            <a:ext cx="348069" cy="91314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-sXBP1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2CB74D0-EA9D-4C4F-8CAE-65584EDD5A1C}"/>
              </a:ext>
            </a:extLst>
          </p:cNvPr>
          <p:cNvSpPr txBox="1"/>
          <p:nvPr/>
        </p:nvSpPr>
        <p:spPr>
          <a:xfrm rot="1852528">
            <a:off x="7132580" y="509614"/>
            <a:ext cx="348069" cy="81891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2% Input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C1BAA1B4-C1C1-4D8A-959E-2BA8B7FC006E}"/>
              </a:ext>
            </a:extLst>
          </p:cNvPr>
          <p:cNvSpPr txBox="1"/>
          <p:nvPr/>
        </p:nvSpPr>
        <p:spPr>
          <a:xfrm rot="1852528">
            <a:off x="7438067" y="145463"/>
            <a:ext cx="348069" cy="121083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l-GR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-Control IgG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08DC85A1-DB87-4BFC-993F-4E9F30B98AA4}"/>
              </a:ext>
            </a:extLst>
          </p:cNvPr>
          <p:cNvSpPr txBox="1"/>
          <p:nvPr/>
        </p:nvSpPr>
        <p:spPr>
          <a:xfrm rot="1852528">
            <a:off x="7604579" y="422057"/>
            <a:ext cx="348069" cy="91314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α-sXBP1</a:t>
            </a:r>
          </a:p>
        </p:txBody>
      </p:sp>
      <p:pic>
        <p:nvPicPr>
          <p:cNvPr id="83" name="Picture 82">
            <a:extLst>
              <a:ext uri="{FF2B5EF4-FFF2-40B4-BE49-F238E27FC236}">
                <a16:creationId xmlns:a16="http://schemas.microsoft.com/office/drawing/2014/main" id="{463D44D3-53EF-4B85-8372-0005461D82F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376" t="10721" r="21653" b="15547"/>
          <a:stretch/>
        </p:blipFill>
        <p:spPr>
          <a:xfrm>
            <a:off x="6679836" y="5457000"/>
            <a:ext cx="1144654" cy="1055579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sp>
        <p:nvSpPr>
          <p:cNvPr id="84" name="TextBox 83">
            <a:extLst>
              <a:ext uri="{FF2B5EF4-FFF2-40B4-BE49-F238E27FC236}">
                <a16:creationId xmlns:a16="http://schemas.microsoft.com/office/drawing/2014/main" id="{F9DFAE9C-3502-4876-9A13-FDB73AB60653}"/>
              </a:ext>
            </a:extLst>
          </p:cNvPr>
          <p:cNvSpPr txBox="1"/>
          <p:nvPr/>
        </p:nvSpPr>
        <p:spPr>
          <a:xfrm>
            <a:off x="7817783" y="6095880"/>
            <a:ext cx="6241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tat3</a:t>
            </a:r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09FB2770-0BE5-4B46-BB86-774289C73F8D}"/>
              </a:ext>
            </a:extLst>
          </p:cNvPr>
          <p:cNvCxnSpPr/>
          <p:nvPr/>
        </p:nvCxnSpPr>
        <p:spPr>
          <a:xfrm>
            <a:off x="7729615" y="6363922"/>
            <a:ext cx="426846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2F4E2D00-D440-4FB2-BB07-CEA66C48F226}"/>
              </a:ext>
            </a:extLst>
          </p:cNvPr>
          <p:cNvCxnSpPr/>
          <p:nvPr/>
        </p:nvCxnSpPr>
        <p:spPr>
          <a:xfrm>
            <a:off x="6577449" y="6156090"/>
            <a:ext cx="240943" cy="0"/>
          </a:xfrm>
          <a:prstGeom prst="line">
            <a:avLst/>
          </a:prstGeom>
          <a:ln w="952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4BDB05D7-7360-4D34-AFD5-516123341F61}"/>
              </a:ext>
            </a:extLst>
          </p:cNvPr>
          <p:cNvSpPr txBox="1"/>
          <p:nvPr/>
        </p:nvSpPr>
        <p:spPr>
          <a:xfrm>
            <a:off x="6210798" y="6002201"/>
            <a:ext cx="4690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500</a:t>
            </a:r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DA3E6245-CFC5-40B6-8400-25125ECD2A51}"/>
              </a:ext>
            </a:extLst>
          </p:cNvPr>
          <p:cNvCxnSpPr/>
          <p:nvPr/>
        </p:nvCxnSpPr>
        <p:spPr>
          <a:xfrm>
            <a:off x="4355995" y="4636856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Connector 88">
            <a:extLst>
              <a:ext uri="{FF2B5EF4-FFF2-40B4-BE49-F238E27FC236}">
                <a16:creationId xmlns:a16="http://schemas.microsoft.com/office/drawing/2014/main" id="{B4744B8D-1848-4BDE-9A2A-2C392B4EAD31}"/>
              </a:ext>
            </a:extLst>
          </p:cNvPr>
          <p:cNvCxnSpPr/>
          <p:nvPr/>
        </p:nvCxnSpPr>
        <p:spPr>
          <a:xfrm>
            <a:off x="4413076" y="3594524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EF4C8B17-6965-457E-B5BC-CAF21330A228}"/>
              </a:ext>
            </a:extLst>
          </p:cNvPr>
          <p:cNvCxnSpPr/>
          <p:nvPr/>
        </p:nvCxnSpPr>
        <p:spPr>
          <a:xfrm>
            <a:off x="4546957" y="2430941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F1BB46DB-7D36-451A-B328-C85D5CE3551E}"/>
              </a:ext>
            </a:extLst>
          </p:cNvPr>
          <p:cNvCxnSpPr/>
          <p:nvPr/>
        </p:nvCxnSpPr>
        <p:spPr>
          <a:xfrm>
            <a:off x="10664894" y="4630132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99311880-AF0F-4C78-A8BA-7CEC13A67D27}"/>
              </a:ext>
            </a:extLst>
          </p:cNvPr>
          <p:cNvCxnSpPr/>
          <p:nvPr/>
        </p:nvCxnSpPr>
        <p:spPr>
          <a:xfrm>
            <a:off x="11046817" y="3128235"/>
            <a:ext cx="381923" cy="0"/>
          </a:xfrm>
          <a:prstGeom prst="line">
            <a:avLst/>
          </a:prstGeom>
          <a:ln w="12700">
            <a:solidFill>
              <a:srgbClr val="0000FF"/>
            </a:solidFill>
            <a:headEnd type="arrow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845638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74</Words>
  <Application>Microsoft Office PowerPoint</Application>
  <PresentationFormat>Widescreen</PresentationFormat>
  <Paragraphs>4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shi, Aniket Sunil</dc:creator>
  <cp:lastModifiedBy>Joshi, Aniket Sunil</cp:lastModifiedBy>
  <cp:revision>1</cp:revision>
  <dcterms:created xsi:type="dcterms:W3CDTF">2025-08-22T22:57:46Z</dcterms:created>
  <dcterms:modified xsi:type="dcterms:W3CDTF">2025-08-23T16:59:48Z</dcterms:modified>
</cp:coreProperties>
</file>